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98" r:id="rId5"/>
  </p:sldIdLst>
  <p:sldSz cx="9601200" cy="12801600" type="A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97" autoAdjust="0"/>
    <p:restoredTop sz="94660"/>
  </p:normalViewPr>
  <p:slideViewPr>
    <p:cSldViewPr snapToGrid="0">
      <p:cViewPr>
        <p:scale>
          <a:sx n="110" d="100"/>
          <a:sy n="110" d="100"/>
        </p:scale>
        <p:origin x="978" y="-25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田　健太朗" userId="bc94bac3-4cb4-4747-a4e6-674ef9948a55" providerId="ADAL" clId="{6709D6C8-D299-463F-91F2-BE72652812B4}"/>
    <pc:docChg chg="delSld modSld">
      <pc:chgData name="西田　健太朗" userId="bc94bac3-4cb4-4747-a4e6-674ef9948a55" providerId="ADAL" clId="{6709D6C8-D299-463F-91F2-BE72652812B4}" dt="2026-01-09T05:35:40.583" v="20" actId="6549"/>
      <pc:docMkLst>
        <pc:docMk/>
      </pc:docMkLst>
      <pc:sldChg chg="modSp mod">
        <pc:chgData name="西田　健太朗" userId="bc94bac3-4cb4-4747-a4e6-674ef9948a55" providerId="ADAL" clId="{6709D6C8-D299-463F-91F2-BE72652812B4}" dt="2026-01-09T05:35:40.583" v="20" actId="6549"/>
        <pc:sldMkLst>
          <pc:docMk/>
          <pc:sldMk cId="3852982278" sldId="298"/>
        </pc:sldMkLst>
        <pc:spChg chg="mod">
          <ac:chgData name="西田　健太朗" userId="bc94bac3-4cb4-4747-a4e6-674ef9948a55" providerId="ADAL" clId="{6709D6C8-D299-463F-91F2-BE72652812B4}" dt="2026-01-09T05:34:41.175" v="4" actId="255"/>
          <ac:spMkLst>
            <pc:docMk/>
            <pc:sldMk cId="3852982278" sldId="298"/>
            <ac:spMk id="2" creationId="{82782675-7101-60C3-1955-A048ADF37A27}"/>
          </ac:spMkLst>
        </pc:spChg>
        <pc:spChg chg="mod">
          <ac:chgData name="西田　健太朗" userId="bc94bac3-4cb4-4747-a4e6-674ef9948a55" providerId="ADAL" clId="{6709D6C8-D299-463F-91F2-BE72652812B4}" dt="2026-01-09T05:34:04.138" v="3" actId="1076"/>
          <ac:spMkLst>
            <pc:docMk/>
            <pc:sldMk cId="3852982278" sldId="298"/>
            <ac:spMk id="4" creationId="{B415DB94-D47C-44F3-AAE1-5240A12A64BA}"/>
          </ac:spMkLst>
        </pc:spChg>
        <pc:spChg chg="mod">
          <ac:chgData name="西田　健太朗" userId="bc94bac3-4cb4-4747-a4e6-674ef9948a55" providerId="ADAL" clId="{6709D6C8-D299-463F-91F2-BE72652812B4}" dt="2026-01-09T05:35:40.583" v="20" actId="6549"/>
          <ac:spMkLst>
            <pc:docMk/>
            <pc:sldMk cId="3852982278" sldId="298"/>
            <ac:spMk id="5" creationId="{4C848D02-968C-CE47-76A5-1DC42B722649}"/>
          </ac:spMkLst>
        </pc:spChg>
        <pc:spChg chg="mod">
          <ac:chgData name="西田　健太朗" userId="bc94bac3-4cb4-4747-a4e6-674ef9948a55" providerId="ADAL" clId="{6709D6C8-D299-463F-91F2-BE72652812B4}" dt="2026-01-09T05:34:41.175" v="4" actId="255"/>
          <ac:spMkLst>
            <pc:docMk/>
            <pc:sldMk cId="3852982278" sldId="298"/>
            <ac:spMk id="10" creationId="{138BFB79-BB4C-BADD-067A-7DEAAC131FF1}"/>
          </ac:spMkLst>
        </pc:spChg>
        <pc:picChg chg="mod">
          <ac:chgData name="西田　健太朗" userId="bc94bac3-4cb4-4747-a4e6-674ef9948a55" providerId="ADAL" clId="{6709D6C8-D299-463F-91F2-BE72652812B4}" dt="2026-01-09T05:33:34.985" v="2" actId="692"/>
          <ac:picMkLst>
            <pc:docMk/>
            <pc:sldMk cId="3852982278" sldId="298"/>
            <ac:picMk id="25" creationId="{589EDC7B-4E5C-E34A-9B29-DCFFE45CFD68}"/>
          </ac:picMkLst>
        </pc:picChg>
        <pc:picChg chg="mod">
          <ac:chgData name="西田　健太朗" userId="bc94bac3-4cb4-4747-a4e6-674ef9948a55" providerId="ADAL" clId="{6709D6C8-D299-463F-91F2-BE72652812B4}" dt="2026-01-09T05:33:34.985" v="2" actId="692"/>
          <ac:picMkLst>
            <pc:docMk/>
            <pc:sldMk cId="3852982278" sldId="298"/>
            <ac:picMk id="37" creationId="{CDF01A07-E7F8-9BA2-8CFF-48B5ED13E796}"/>
          </ac:picMkLst>
        </pc:picChg>
      </pc:sldChg>
      <pc:sldChg chg="del">
        <pc:chgData name="西田　健太朗" userId="bc94bac3-4cb4-4747-a4e6-674ef9948a55" providerId="ADAL" clId="{6709D6C8-D299-463F-91F2-BE72652812B4}" dt="2026-01-08T08:40:10.661" v="0" actId="2696"/>
        <pc:sldMkLst>
          <pc:docMk/>
          <pc:sldMk cId="116731960" sldId="299"/>
        </pc:sldMkLst>
      </pc:sldChg>
      <pc:sldChg chg="del">
        <pc:chgData name="西田　健太朗" userId="bc94bac3-4cb4-4747-a4e6-674ef9948a55" providerId="ADAL" clId="{6709D6C8-D299-463F-91F2-BE72652812B4}" dt="2026-01-08T08:40:10.661" v="0" actId="2696"/>
        <pc:sldMkLst>
          <pc:docMk/>
          <pc:sldMk cId="3918428493" sldId="300"/>
        </pc:sldMkLst>
      </pc:sldChg>
      <pc:sldChg chg="del">
        <pc:chgData name="西田　健太朗" userId="bc94bac3-4cb4-4747-a4e6-674ef9948a55" providerId="ADAL" clId="{6709D6C8-D299-463F-91F2-BE72652812B4}" dt="2026-01-08T08:40:10.661" v="0" actId="2696"/>
        <pc:sldMkLst>
          <pc:docMk/>
          <pc:sldMk cId="1081936292" sldId="301"/>
        </pc:sldMkLst>
      </pc:sldChg>
      <pc:sldChg chg="del">
        <pc:chgData name="西田　健太朗" userId="bc94bac3-4cb4-4747-a4e6-674ef9948a55" providerId="ADAL" clId="{6709D6C8-D299-463F-91F2-BE72652812B4}" dt="2026-01-08T08:40:10.661" v="0" actId="2696"/>
        <pc:sldMkLst>
          <pc:docMk/>
          <pc:sldMk cId="1594321563" sldId="30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619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940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89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64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889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725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397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013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166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269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76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図 36" descr="時計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CDF01A07-E7F8-9BA2-8CFF-48B5ED13E7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93" t="48994" r="17688" b="37647"/>
          <a:stretch/>
        </p:blipFill>
        <p:spPr>
          <a:xfrm>
            <a:off x="3009708" y="5075060"/>
            <a:ext cx="5155063" cy="7418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図 24" descr="コンピュータ, 時計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589EDC7B-4E5C-E34A-9B29-DCFFE45CFD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94" t="23596" r="17687" b="63044"/>
          <a:stretch/>
        </p:blipFill>
        <p:spPr>
          <a:xfrm>
            <a:off x="3009708" y="4269076"/>
            <a:ext cx="5155064" cy="74180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15DB94-D47C-44F3-AAE1-5240A12A64BA}"/>
              </a:ext>
            </a:extLst>
          </p:cNvPr>
          <p:cNvSpPr txBox="1"/>
          <p:nvPr/>
        </p:nvSpPr>
        <p:spPr>
          <a:xfrm>
            <a:off x="176187" y="130370"/>
            <a:ext cx="42883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l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Fig.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D37A7AF-103B-4EEA-976A-9722DFCCFA92}"/>
              </a:ext>
            </a:extLst>
          </p:cNvPr>
          <p:cNvSpPr txBox="1"/>
          <p:nvPr/>
        </p:nvSpPr>
        <p:spPr>
          <a:xfrm rot="19272057">
            <a:off x="2924884" y="3668361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9D024E2-739F-4033-A266-BBDDB4FE864C}"/>
              </a:ext>
            </a:extLst>
          </p:cNvPr>
          <p:cNvSpPr txBox="1"/>
          <p:nvPr/>
        </p:nvSpPr>
        <p:spPr>
          <a:xfrm flipH="1">
            <a:off x="5339349" y="3847305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56D1809-F3F6-4066-8E5E-C19A3BFF3B7A}"/>
              </a:ext>
            </a:extLst>
          </p:cNvPr>
          <p:cNvSpPr txBox="1"/>
          <p:nvPr/>
        </p:nvSpPr>
        <p:spPr>
          <a:xfrm>
            <a:off x="3978776" y="3847305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B600F71-A8CE-42D4-8DF9-72CE463DFB99}"/>
              </a:ext>
            </a:extLst>
          </p:cNvPr>
          <p:cNvSpPr txBox="1"/>
          <p:nvPr/>
        </p:nvSpPr>
        <p:spPr>
          <a:xfrm>
            <a:off x="4683146" y="3847305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08B5DC4A-1DE8-4B73-9D7E-B29C5B2508AE}"/>
              </a:ext>
            </a:extLst>
          </p:cNvPr>
          <p:cNvCxnSpPr>
            <a:cxnSpLocks/>
          </p:cNvCxnSpPr>
          <p:nvPr/>
        </p:nvCxnSpPr>
        <p:spPr>
          <a:xfrm>
            <a:off x="4018771" y="3808375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72D40FD9-B8BE-4409-8B9D-F151C96DA494}"/>
              </a:ext>
            </a:extLst>
          </p:cNvPr>
          <p:cNvSpPr/>
          <p:nvPr/>
        </p:nvSpPr>
        <p:spPr>
          <a:xfrm>
            <a:off x="3873126" y="3483946"/>
            <a:ext cx="21034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D499929-F128-FB24-BA1C-92675D2DBFB9}"/>
              </a:ext>
            </a:extLst>
          </p:cNvPr>
          <p:cNvSpPr txBox="1"/>
          <p:nvPr/>
        </p:nvSpPr>
        <p:spPr>
          <a:xfrm flipH="1">
            <a:off x="7399064" y="3847498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BAC6DFF-7362-D99F-1EBE-1D521660FF7E}"/>
              </a:ext>
            </a:extLst>
          </p:cNvPr>
          <p:cNvSpPr txBox="1"/>
          <p:nvPr/>
        </p:nvSpPr>
        <p:spPr>
          <a:xfrm>
            <a:off x="6012364" y="3847498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213DAB3-E230-A145-5AD8-959E90ACB5E4}"/>
              </a:ext>
            </a:extLst>
          </p:cNvPr>
          <p:cNvSpPr txBox="1"/>
          <p:nvPr/>
        </p:nvSpPr>
        <p:spPr>
          <a:xfrm>
            <a:off x="6725443" y="3847498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B49E61B7-7216-3129-F477-5F1A97FD69AE}"/>
              </a:ext>
            </a:extLst>
          </p:cNvPr>
          <p:cNvCxnSpPr>
            <a:cxnSpLocks/>
          </p:cNvCxnSpPr>
          <p:nvPr/>
        </p:nvCxnSpPr>
        <p:spPr>
          <a:xfrm>
            <a:off x="4018771" y="3808568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948873A6-DDBB-B264-65CF-3C9FDBB265FF}"/>
              </a:ext>
            </a:extLst>
          </p:cNvPr>
          <p:cNvSpPr/>
          <p:nvPr/>
        </p:nvSpPr>
        <p:spPr>
          <a:xfrm>
            <a:off x="5889162" y="3483946"/>
            <a:ext cx="21034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443BF6FA-019C-8E42-B11E-A66FE9E7FFF7}"/>
              </a:ext>
            </a:extLst>
          </p:cNvPr>
          <p:cNvCxnSpPr>
            <a:cxnSpLocks/>
          </p:cNvCxnSpPr>
          <p:nvPr/>
        </p:nvCxnSpPr>
        <p:spPr>
          <a:xfrm>
            <a:off x="6034808" y="3812918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44BB8A7E-CA5A-620A-BE2B-AD9BD5A1773F}"/>
              </a:ext>
            </a:extLst>
          </p:cNvPr>
          <p:cNvCxnSpPr>
            <a:cxnSpLocks/>
          </p:cNvCxnSpPr>
          <p:nvPr/>
        </p:nvCxnSpPr>
        <p:spPr>
          <a:xfrm>
            <a:off x="3206909" y="3438295"/>
            <a:ext cx="47003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0CBD019-00D6-7115-B89E-48419652AF68}"/>
              </a:ext>
            </a:extLst>
          </p:cNvPr>
          <p:cNvSpPr txBox="1"/>
          <p:nvPr/>
        </p:nvSpPr>
        <p:spPr>
          <a:xfrm>
            <a:off x="5299595" y="3145200"/>
            <a:ext cx="7933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ack</a:t>
            </a:r>
            <a:endParaRPr lang="ja-JP" altLang="en-US" sz="1600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4B88679-F02F-AD25-0E6B-42873FEF0325}"/>
              </a:ext>
            </a:extLst>
          </p:cNvPr>
          <p:cNvGrpSpPr/>
          <p:nvPr/>
        </p:nvGrpSpPr>
        <p:grpSpPr>
          <a:xfrm>
            <a:off x="8200163" y="4692649"/>
            <a:ext cx="702681" cy="338554"/>
            <a:chOff x="3388623" y="4387335"/>
            <a:chExt cx="772949" cy="338554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852DBE66-DA36-561C-0089-7B862F0974BC}"/>
                </a:ext>
              </a:extLst>
            </p:cNvPr>
            <p:cNvCxnSpPr/>
            <p:nvPr/>
          </p:nvCxnSpPr>
          <p:spPr>
            <a:xfrm>
              <a:off x="3388623" y="4572001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9C50E1BB-A427-0FB3-31CF-C3695AC5B7BA}"/>
                </a:ext>
              </a:extLst>
            </p:cNvPr>
            <p:cNvSpPr txBox="1"/>
            <p:nvPr/>
          </p:nvSpPr>
          <p:spPr>
            <a:xfrm>
              <a:off x="3635466" y="4387335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20234570-494A-35A1-2B65-5C1BC4F17B13}"/>
              </a:ext>
            </a:extLst>
          </p:cNvPr>
          <p:cNvGrpSpPr/>
          <p:nvPr/>
        </p:nvGrpSpPr>
        <p:grpSpPr>
          <a:xfrm>
            <a:off x="8200163" y="4135303"/>
            <a:ext cx="702681" cy="338554"/>
            <a:chOff x="3402124" y="3657992"/>
            <a:chExt cx="772949" cy="338554"/>
          </a:xfrm>
        </p:grpSpPr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90E2F61B-5A49-934C-0155-05F1308D64CE}"/>
                </a:ext>
              </a:extLst>
            </p:cNvPr>
            <p:cNvCxnSpPr/>
            <p:nvPr/>
          </p:nvCxnSpPr>
          <p:spPr>
            <a:xfrm>
              <a:off x="3402124" y="384265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CE65F6E-FD9B-BE43-E97C-B2BDA64FDD55}"/>
                </a:ext>
              </a:extLst>
            </p:cNvPr>
            <p:cNvSpPr txBox="1"/>
            <p:nvPr/>
          </p:nvSpPr>
          <p:spPr>
            <a:xfrm>
              <a:off x="3648967" y="3657992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9E53E1F6-BCBF-7A3C-0854-32844F8ECECA}"/>
              </a:ext>
            </a:extLst>
          </p:cNvPr>
          <p:cNvGrpSpPr/>
          <p:nvPr/>
        </p:nvGrpSpPr>
        <p:grpSpPr>
          <a:xfrm>
            <a:off x="8194989" y="4930900"/>
            <a:ext cx="599214" cy="338554"/>
            <a:chOff x="3453696" y="7544499"/>
            <a:chExt cx="659135" cy="338554"/>
          </a:xfrm>
        </p:grpSpPr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B9EBC34F-903B-889E-7353-D7CD5ADCE42F}"/>
                </a:ext>
              </a:extLst>
            </p:cNvPr>
            <p:cNvCxnSpPr/>
            <p:nvPr/>
          </p:nvCxnSpPr>
          <p:spPr>
            <a:xfrm>
              <a:off x="3453696" y="7729165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64934C1-7E9F-BEE0-5A5C-A4725F2D5928}"/>
                </a:ext>
              </a:extLst>
            </p:cNvPr>
            <p:cNvSpPr txBox="1"/>
            <p:nvPr/>
          </p:nvSpPr>
          <p:spPr>
            <a:xfrm>
              <a:off x="3700539" y="7544499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737CF376-9A90-9FA4-76C1-42408C645A75}"/>
              </a:ext>
            </a:extLst>
          </p:cNvPr>
          <p:cNvGrpSpPr/>
          <p:nvPr/>
        </p:nvGrpSpPr>
        <p:grpSpPr>
          <a:xfrm>
            <a:off x="8194989" y="5496568"/>
            <a:ext cx="599214" cy="338554"/>
            <a:chOff x="3467197" y="9439312"/>
            <a:chExt cx="659135" cy="338554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2C578897-0071-8E65-E938-25ED65744564}"/>
                </a:ext>
              </a:extLst>
            </p:cNvPr>
            <p:cNvCxnSpPr/>
            <p:nvPr/>
          </p:nvCxnSpPr>
          <p:spPr>
            <a:xfrm>
              <a:off x="3467197" y="962397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DC4320BD-D4FB-1C17-DE32-E32E92FD0CC0}"/>
                </a:ext>
              </a:extLst>
            </p:cNvPr>
            <p:cNvSpPr txBox="1"/>
            <p:nvPr/>
          </p:nvSpPr>
          <p:spPr>
            <a:xfrm>
              <a:off x="3714040" y="9439312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99D34C6-60E6-319D-4B6E-BAB2A274CEB5}"/>
              </a:ext>
            </a:extLst>
          </p:cNvPr>
          <p:cNvSpPr txBox="1"/>
          <p:nvPr/>
        </p:nvSpPr>
        <p:spPr>
          <a:xfrm>
            <a:off x="8329748" y="3952272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9FAA6F5-B768-0E11-16E4-ABFD66EF773C}"/>
              </a:ext>
            </a:extLst>
          </p:cNvPr>
          <p:cNvSpPr txBox="1"/>
          <p:nvPr/>
        </p:nvSpPr>
        <p:spPr>
          <a:xfrm>
            <a:off x="1842040" y="5241378"/>
            <a:ext cx="861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53853"/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2" name="矢印: 右 21">
            <a:extLst>
              <a:ext uri="{FF2B5EF4-FFF2-40B4-BE49-F238E27FC236}">
                <a16:creationId xmlns:a16="http://schemas.microsoft.com/office/drawing/2014/main" id="{5303DC9D-288F-D0C6-D59E-C75847541B82}"/>
              </a:ext>
            </a:extLst>
          </p:cNvPr>
          <p:cNvSpPr/>
          <p:nvPr/>
        </p:nvSpPr>
        <p:spPr>
          <a:xfrm>
            <a:off x="2642685" y="4563321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DCFF1917-617F-F787-E8BA-937103F16A38}"/>
              </a:ext>
            </a:extLst>
          </p:cNvPr>
          <p:cNvSpPr/>
          <p:nvPr/>
        </p:nvSpPr>
        <p:spPr>
          <a:xfrm>
            <a:off x="2650545" y="5365418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29019750-F9D8-F237-7685-1DFB90B70284}"/>
              </a:ext>
            </a:extLst>
          </p:cNvPr>
          <p:cNvPicPr>
            <a:picLocks/>
          </p:cNvPicPr>
          <p:nvPr/>
        </p:nvPicPr>
        <p:blipFill>
          <a:blip r:embed="rId4"/>
          <a:srcRect l="4742" b="16203"/>
          <a:stretch/>
        </p:blipFill>
        <p:spPr>
          <a:xfrm>
            <a:off x="2903220" y="5954794"/>
            <a:ext cx="5075336" cy="229893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782675-7101-60C3-1955-A048ADF37A27}"/>
              </a:ext>
            </a:extLst>
          </p:cNvPr>
          <p:cNvSpPr txBox="1"/>
          <p:nvPr/>
        </p:nvSpPr>
        <p:spPr>
          <a:xfrm>
            <a:off x="1558557" y="3268475"/>
            <a:ext cx="3513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90840">
              <a:defRPr/>
            </a:pPr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en-US" altLang="ja-JP" sz="2400" dirty="0">
              <a:solidFill>
                <a:prstClr val="black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C848D02-968C-CE47-76A5-1DC42B722649}"/>
              </a:ext>
            </a:extLst>
          </p:cNvPr>
          <p:cNvSpPr txBox="1"/>
          <p:nvPr/>
        </p:nvSpPr>
        <p:spPr>
          <a:xfrm rot="16200000">
            <a:off x="1128967" y="6878392"/>
            <a:ext cx="2296784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expression levels </a:t>
            </a:r>
          </a:p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.u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.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38BFB79-BB4C-BADD-067A-7DEAAC131FF1}"/>
              </a:ext>
            </a:extLst>
          </p:cNvPr>
          <p:cNvSpPr/>
          <p:nvPr/>
        </p:nvSpPr>
        <p:spPr>
          <a:xfrm>
            <a:off x="1558557" y="592406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lang="ja-JP" altLang="en-US" sz="24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020DF0A-EDF7-B4E5-C601-FD1A572D9A53}"/>
              </a:ext>
            </a:extLst>
          </p:cNvPr>
          <p:cNvSpPr txBox="1"/>
          <p:nvPr/>
        </p:nvSpPr>
        <p:spPr>
          <a:xfrm>
            <a:off x="1692618" y="4458888"/>
            <a:ext cx="999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53853"/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endParaRPr kumimoji="1"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0C97BD3-D933-5D86-985B-6983E9CC86A4}"/>
              </a:ext>
            </a:extLst>
          </p:cNvPr>
          <p:cNvSpPr txBox="1"/>
          <p:nvPr/>
        </p:nvSpPr>
        <p:spPr>
          <a:xfrm rot="19272057">
            <a:off x="2587306" y="8407395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CA16DA0-A902-FDCA-6B6F-008CCE845207}"/>
              </a:ext>
            </a:extLst>
          </p:cNvPr>
          <p:cNvSpPr txBox="1"/>
          <p:nvPr/>
        </p:nvSpPr>
        <p:spPr>
          <a:xfrm flipH="1">
            <a:off x="5132076" y="8238118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C41D0A2-8103-5559-D6DA-840A807A84EC}"/>
              </a:ext>
            </a:extLst>
          </p:cNvPr>
          <p:cNvSpPr txBox="1"/>
          <p:nvPr/>
        </p:nvSpPr>
        <p:spPr>
          <a:xfrm>
            <a:off x="3771503" y="8238118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A815DD1-ACDF-2102-077B-BC980E3702CD}"/>
              </a:ext>
            </a:extLst>
          </p:cNvPr>
          <p:cNvSpPr txBox="1"/>
          <p:nvPr/>
        </p:nvSpPr>
        <p:spPr>
          <a:xfrm>
            <a:off x="4475873" y="8238118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E38D3E06-FB99-F33B-79B7-45175AD10D59}"/>
              </a:ext>
            </a:extLst>
          </p:cNvPr>
          <p:cNvSpPr/>
          <p:nvPr/>
        </p:nvSpPr>
        <p:spPr>
          <a:xfrm>
            <a:off x="3747213" y="857971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8B790BC-2724-9D4B-2429-A026EA105D1D}"/>
              </a:ext>
            </a:extLst>
          </p:cNvPr>
          <p:cNvSpPr txBox="1"/>
          <p:nvPr/>
        </p:nvSpPr>
        <p:spPr>
          <a:xfrm flipH="1">
            <a:off x="7242591" y="8238311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345988A-B6DB-DAB0-1CE3-17F08845F5BD}"/>
              </a:ext>
            </a:extLst>
          </p:cNvPr>
          <p:cNvSpPr txBox="1"/>
          <p:nvPr/>
        </p:nvSpPr>
        <p:spPr>
          <a:xfrm>
            <a:off x="5887641" y="8238311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E8B0991-8268-78AB-79F4-B0A7D9E40023}"/>
              </a:ext>
            </a:extLst>
          </p:cNvPr>
          <p:cNvSpPr txBox="1"/>
          <p:nvPr/>
        </p:nvSpPr>
        <p:spPr>
          <a:xfrm>
            <a:off x="6575320" y="8238311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DE0858F-1EB4-BF22-3394-0DCC4ECE9AD6}"/>
              </a:ext>
            </a:extLst>
          </p:cNvPr>
          <p:cNvCxnSpPr>
            <a:cxnSpLocks/>
          </p:cNvCxnSpPr>
          <p:nvPr/>
        </p:nvCxnSpPr>
        <p:spPr>
          <a:xfrm>
            <a:off x="3760736" y="856505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464AE5D1-3AE0-2B59-3C8E-090BB9567FED}"/>
              </a:ext>
            </a:extLst>
          </p:cNvPr>
          <p:cNvSpPr/>
          <p:nvPr/>
        </p:nvSpPr>
        <p:spPr>
          <a:xfrm>
            <a:off x="5890249" y="857971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AF79A0D9-3998-B73A-F497-632AA5F3D423}"/>
              </a:ext>
            </a:extLst>
          </p:cNvPr>
          <p:cNvCxnSpPr>
            <a:cxnSpLocks/>
          </p:cNvCxnSpPr>
          <p:nvPr/>
        </p:nvCxnSpPr>
        <p:spPr>
          <a:xfrm>
            <a:off x="5865673" y="856505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D8BDB39-92EA-2F1C-DF61-6255E48D5EB3}"/>
              </a:ext>
            </a:extLst>
          </p:cNvPr>
          <p:cNvSpPr txBox="1"/>
          <p:nvPr/>
        </p:nvSpPr>
        <p:spPr>
          <a:xfrm>
            <a:off x="2594682" y="8031362"/>
            <a:ext cx="42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0123ED6-7E31-A36A-166B-801DAA43D087}"/>
              </a:ext>
            </a:extLst>
          </p:cNvPr>
          <p:cNvSpPr txBox="1"/>
          <p:nvPr/>
        </p:nvSpPr>
        <p:spPr>
          <a:xfrm>
            <a:off x="2512069" y="7724056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0F7ABBD-15DB-E285-1C77-288858CAE7DA}"/>
              </a:ext>
            </a:extLst>
          </p:cNvPr>
          <p:cNvSpPr txBox="1"/>
          <p:nvPr/>
        </p:nvSpPr>
        <p:spPr>
          <a:xfrm>
            <a:off x="2512069" y="7429955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6DB94C8-F05E-F70B-C13A-5B19F3F9E17C}"/>
              </a:ext>
            </a:extLst>
          </p:cNvPr>
          <p:cNvSpPr txBox="1"/>
          <p:nvPr/>
        </p:nvSpPr>
        <p:spPr>
          <a:xfrm>
            <a:off x="2512069" y="7138523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3F55F75-BC24-EDDD-6D7F-5F5AB12384F6}"/>
              </a:ext>
            </a:extLst>
          </p:cNvPr>
          <p:cNvSpPr txBox="1"/>
          <p:nvPr/>
        </p:nvSpPr>
        <p:spPr>
          <a:xfrm>
            <a:off x="2512069" y="6842276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B7CBE8F-C2FB-3F49-180E-035B31463B31}"/>
              </a:ext>
            </a:extLst>
          </p:cNvPr>
          <p:cNvSpPr txBox="1"/>
          <p:nvPr/>
        </p:nvSpPr>
        <p:spPr>
          <a:xfrm>
            <a:off x="2512069" y="6548332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BE1FDBD-C3A1-4B9E-FB2A-C7EFCA18D9C2}"/>
              </a:ext>
            </a:extLst>
          </p:cNvPr>
          <p:cNvSpPr txBox="1"/>
          <p:nvPr/>
        </p:nvSpPr>
        <p:spPr>
          <a:xfrm>
            <a:off x="2512069" y="6253643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42ACD42-98F3-B603-1F7A-0D4F56703D10}"/>
              </a:ext>
            </a:extLst>
          </p:cNvPr>
          <p:cNvSpPr txBox="1"/>
          <p:nvPr/>
        </p:nvSpPr>
        <p:spPr>
          <a:xfrm>
            <a:off x="2512069" y="5950651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2982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C33B5BD4E644C4D8D57583994C724B6" ma:contentTypeVersion="15" ma:contentTypeDescription="新しいドキュメントを作成します。" ma:contentTypeScope="" ma:versionID="581ef8f523f6df2d3dcbd90b34743d18">
  <xsd:schema xmlns:xsd="http://www.w3.org/2001/XMLSchema" xmlns:xs="http://www.w3.org/2001/XMLSchema" xmlns:p="http://schemas.microsoft.com/office/2006/metadata/properties" xmlns:ns3="d46048f6-b81f-43a4-8afc-a6570ccfb14b" xmlns:ns4="51e9e23c-c15a-4fef-a277-c63d94d447eb" targetNamespace="http://schemas.microsoft.com/office/2006/metadata/properties" ma:root="true" ma:fieldsID="c1daa78ff8b52bbdaa7f01933a7c6b7a" ns3:_="" ns4:_="">
    <xsd:import namespace="d46048f6-b81f-43a4-8afc-a6570ccfb14b"/>
    <xsd:import namespace="51e9e23c-c15a-4fef-a277-c63d94d447e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46048f6-b81f-43a4-8afc-a6570ccfb14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e9e23c-c15a-4fef-a277-c63d94d447e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46048f6-b81f-43a4-8afc-a6570ccfb14b" xsi:nil="true"/>
  </documentManagement>
</p:properties>
</file>

<file path=customXml/itemProps1.xml><?xml version="1.0" encoding="utf-8"?>
<ds:datastoreItem xmlns:ds="http://schemas.openxmlformats.org/officeDocument/2006/customXml" ds:itemID="{ABD4149F-7E02-4E7F-94BF-1A6DE4B3BD6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11CE79A-5FB6-4A5F-AED1-DD9FF18F6B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46048f6-b81f-43a4-8afc-a6570ccfb14b"/>
    <ds:schemaRef ds:uri="51e9e23c-c15a-4fef-a277-c63d94d447e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4E759A7-835B-42E2-BA5B-EB89C93D1B70}">
  <ds:schemaRefs>
    <ds:schemaRef ds:uri="http://www.w3.org/XML/1998/namespace"/>
    <ds:schemaRef ds:uri="http://purl.org/dc/elements/1.1/"/>
    <ds:schemaRef ds:uri="http://schemas.microsoft.com/office/2006/metadata/properties"/>
    <ds:schemaRef ds:uri="http://schemas.microsoft.com/office/infopath/2007/PartnerControls"/>
    <ds:schemaRef ds:uri="d46048f6-b81f-43a4-8afc-a6570ccfb14b"/>
    <ds:schemaRef ds:uri="51e9e23c-c15a-4fef-a277-c63d94d447eb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7</TotalTime>
  <Words>87</Words>
  <Application>Microsoft Office PowerPoint</Application>
  <PresentationFormat>A3 297x420 mm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薬学国試</dc:creator>
  <cp:lastModifiedBy>西田　健太朗</cp:lastModifiedBy>
  <cp:revision>86</cp:revision>
  <cp:lastPrinted>2024-02-26T10:17:30Z</cp:lastPrinted>
  <dcterms:created xsi:type="dcterms:W3CDTF">2022-11-15T04:47:13Z</dcterms:created>
  <dcterms:modified xsi:type="dcterms:W3CDTF">2026-01-09T05:35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C33B5BD4E644C4D8D57583994C724B6</vt:lpwstr>
  </property>
</Properties>
</file>